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bin" ContentType="application/vnd.openxmlformats-officedocument.presentationml.printerSettings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3" r:id="rId4"/>
    <p:sldId id="264" r:id="rId5"/>
    <p:sldId id="265" r:id="rId6"/>
    <p:sldId id="266" r:id="rId7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5" d="100"/>
          <a:sy n="85" d="100"/>
        </p:scale>
        <p:origin x="-4992" y="-72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interSettings" Target="printerSettings/printerSettings1.bin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avoro%20CCCH\CCCH%20espressione\TaAffx.106069.1.S1_a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oglio2!$B$2</c:f>
              <c:strCache>
                <c:ptCount val="1"/>
                <c:pt idx="0">
                  <c:v>TaTZF4</c:v>
                </c:pt>
              </c:strCache>
            </c:strRef>
          </c:tx>
          <c:cat>
            <c:strRef>
              <c:f>Foglio2!$A$3:$A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B$3:$B$15</c:f>
              <c:numCache>
                <c:formatCode>0.00</c:formatCode>
                <c:ptCount val="13"/>
                <c:pt idx="0">
                  <c:v>2.6586308795203</c:v>
                </c:pt>
                <c:pt idx="1">
                  <c:v>1.591488951453001</c:v>
                </c:pt>
                <c:pt idx="2">
                  <c:v>1.993460317326066</c:v>
                </c:pt>
                <c:pt idx="3">
                  <c:v>2.877298057438833</c:v>
                </c:pt>
                <c:pt idx="4">
                  <c:v>1.7480937256398</c:v>
                </c:pt>
                <c:pt idx="5">
                  <c:v>2.360587377403635</c:v>
                </c:pt>
                <c:pt idx="6">
                  <c:v>2.339678788128662</c:v>
                </c:pt>
                <c:pt idx="7">
                  <c:v>2.246780054435168</c:v>
                </c:pt>
                <c:pt idx="8">
                  <c:v>2.60400036049</c:v>
                </c:pt>
                <c:pt idx="9">
                  <c:v>2.630655735167</c:v>
                </c:pt>
                <c:pt idx="10">
                  <c:v>1.175608440484646</c:v>
                </c:pt>
                <c:pt idx="11">
                  <c:v>1.602007330172038</c:v>
                </c:pt>
                <c:pt idx="12">
                  <c:v>2.68363726704847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oglio2!$C$2</c:f>
              <c:strCache>
                <c:ptCount val="1"/>
                <c:pt idx="0">
                  <c:v>TaTZF6</c:v>
                </c:pt>
              </c:strCache>
            </c:strRef>
          </c:tx>
          <c:cat>
            <c:strRef>
              <c:f>Foglio2!$A$3:$A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C$3:$C$15</c:f>
              <c:numCache>
                <c:formatCode>0.00</c:formatCode>
                <c:ptCount val="13"/>
                <c:pt idx="0">
                  <c:v>6.9830958166038</c:v>
                </c:pt>
                <c:pt idx="1">
                  <c:v>6.960576468467925</c:v>
                </c:pt>
                <c:pt idx="2">
                  <c:v>7.001976533651368</c:v>
                </c:pt>
                <c:pt idx="3">
                  <c:v>7.5887741421074</c:v>
                </c:pt>
                <c:pt idx="4">
                  <c:v>7.06257820969019</c:v>
                </c:pt>
                <c:pt idx="5">
                  <c:v>5.985768815000843</c:v>
                </c:pt>
                <c:pt idx="6">
                  <c:v>7.221944543625167</c:v>
                </c:pt>
                <c:pt idx="7">
                  <c:v>7.61644253549497</c:v>
                </c:pt>
                <c:pt idx="8">
                  <c:v>8.037157795045065</c:v>
                </c:pt>
                <c:pt idx="9">
                  <c:v>5.255089804608766</c:v>
                </c:pt>
                <c:pt idx="10">
                  <c:v>6.8724884687341</c:v>
                </c:pt>
                <c:pt idx="11">
                  <c:v>6.24781535462103</c:v>
                </c:pt>
                <c:pt idx="12">
                  <c:v>6.381632263962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oglio2!$D$2</c:f>
              <c:strCache>
                <c:ptCount val="1"/>
                <c:pt idx="0">
                  <c:v>TuTZF1</c:v>
                </c:pt>
              </c:strCache>
            </c:strRef>
          </c:tx>
          <c:cat>
            <c:strRef>
              <c:f>Foglio2!$A$3:$A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D$3:$D$15</c:f>
              <c:numCache>
                <c:formatCode>0.00</c:formatCode>
                <c:ptCount val="13"/>
                <c:pt idx="0">
                  <c:v>9.721444583300865</c:v>
                </c:pt>
                <c:pt idx="1">
                  <c:v>9.783320923069398</c:v>
                </c:pt>
                <c:pt idx="2">
                  <c:v>9.88928080361265</c:v>
                </c:pt>
                <c:pt idx="3">
                  <c:v>9.956216393131034</c:v>
                </c:pt>
                <c:pt idx="4">
                  <c:v>9.447253376751298</c:v>
                </c:pt>
                <c:pt idx="5">
                  <c:v>8.806840406868804</c:v>
                </c:pt>
                <c:pt idx="6">
                  <c:v>9.74325778682198</c:v>
                </c:pt>
                <c:pt idx="7">
                  <c:v>9.721570003140789</c:v>
                </c:pt>
                <c:pt idx="8">
                  <c:v>10.386176724763</c:v>
                </c:pt>
                <c:pt idx="9">
                  <c:v>9.0382035390816</c:v>
                </c:pt>
                <c:pt idx="10">
                  <c:v>9.597168361588887</c:v>
                </c:pt>
                <c:pt idx="11">
                  <c:v>9.623255231389132</c:v>
                </c:pt>
                <c:pt idx="12">
                  <c:v>8.8290795722096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oglio2!$E$2</c:f>
              <c:strCache>
                <c:ptCount val="1"/>
                <c:pt idx="0">
                  <c:v>TaTFZ3</c:v>
                </c:pt>
              </c:strCache>
            </c:strRef>
          </c:tx>
          <c:cat>
            <c:strRef>
              <c:f>Foglio2!$A$3:$A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E$3:$E$15</c:f>
              <c:numCache>
                <c:formatCode>0.00</c:formatCode>
                <c:ptCount val="13"/>
                <c:pt idx="0">
                  <c:v>9.74658798423058</c:v>
                </c:pt>
                <c:pt idx="1">
                  <c:v>10.61826036797299</c:v>
                </c:pt>
                <c:pt idx="2">
                  <c:v>10.77766629174001</c:v>
                </c:pt>
                <c:pt idx="3">
                  <c:v>11.88835140508433</c:v>
                </c:pt>
                <c:pt idx="4">
                  <c:v>11.20469657645868</c:v>
                </c:pt>
                <c:pt idx="5">
                  <c:v>11.08651782717435</c:v>
                </c:pt>
                <c:pt idx="6">
                  <c:v>10.478677076815</c:v>
                </c:pt>
                <c:pt idx="7">
                  <c:v>12.246813593807</c:v>
                </c:pt>
                <c:pt idx="8">
                  <c:v>11.49075150114534</c:v>
                </c:pt>
                <c:pt idx="9">
                  <c:v>10.37695191885501</c:v>
                </c:pt>
                <c:pt idx="10">
                  <c:v>9.463814135459404</c:v>
                </c:pt>
                <c:pt idx="11">
                  <c:v>9.37079723170418</c:v>
                </c:pt>
                <c:pt idx="12">
                  <c:v>11.08192545236333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Foglio2!$F$2</c:f>
              <c:strCache>
                <c:ptCount val="1"/>
                <c:pt idx="0">
                  <c:v>TaTZF2/TaTZF7</c:v>
                </c:pt>
              </c:strCache>
            </c:strRef>
          </c:tx>
          <c:cat>
            <c:strRef>
              <c:f>Foglio2!$A$3:$A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F$3:$F$15</c:f>
              <c:numCache>
                <c:formatCode>0.00</c:formatCode>
                <c:ptCount val="13"/>
                <c:pt idx="0">
                  <c:v>9.194892077739501</c:v>
                </c:pt>
                <c:pt idx="1">
                  <c:v>10.42656879697467</c:v>
                </c:pt>
                <c:pt idx="2">
                  <c:v>9.869718197518066</c:v>
                </c:pt>
                <c:pt idx="3">
                  <c:v>11.50060546658267</c:v>
                </c:pt>
                <c:pt idx="4">
                  <c:v>11.37845671059335</c:v>
                </c:pt>
                <c:pt idx="5">
                  <c:v>13.13315146501765</c:v>
                </c:pt>
                <c:pt idx="6">
                  <c:v>8.993575775951861</c:v>
                </c:pt>
                <c:pt idx="7">
                  <c:v>12.66848876568367</c:v>
                </c:pt>
                <c:pt idx="8">
                  <c:v>10.20102838925548</c:v>
                </c:pt>
                <c:pt idx="9">
                  <c:v>10.769860707955</c:v>
                </c:pt>
                <c:pt idx="10">
                  <c:v>9.85532263803205</c:v>
                </c:pt>
                <c:pt idx="11">
                  <c:v>8.41458423487282</c:v>
                </c:pt>
                <c:pt idx="12">
                  <c:v>9.9372159515442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7646440"/>
        <c:axId val="-2127643352"/>
      </c:lineChart>
      <c:catAx>
        <c:axId val="-21276464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800000"/>
          <a:lstStyle/>
          <a:p>
            <a:pPr>
              <a:defRPr/>
            </a:pPr>
            <a:endParaRPr lang="it-IT"/>
          </a:p>
        </c:txPr>
        <c:crossAx val="-2127643352"/>
        <c:crosses val="autoZero"/>
        <c:auto val="1"/>
        <c:lblAlgn val="ctr"/>
        <c:lblOffset val="100"/>
        <c:tickLblSkip val="1"/>
        <c:noMultiLvlLbl val="0"/>
      </c:catAx>
      <c:valAx>
        <c:axId val="-2127643352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-212764644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2!$H$2</c:f>
              <c:strCache>
                <c:ptCount val="1"/>
                <c:pt idx="0">
                  <c:v>TaTFZ1/TdTZF1</c:v>
                </c:pt>
              </c:strCache>
            </c:strRef>
          </c:tx>
          <c:cat>
            <c:strRef>
              <c:f>Foglio2!$G$3:$G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H$3:$H$15</c:f>
              <c:numCache>
                <c:formatCode>0.00</c:formatCode>
                <c:ptCount val="13"/>
                <c:pt idx="0">
                  <c:v>7.162959420385784</c:v>
                </c:pt>
                <c:pt idx="1">
                  <c:v>7.098544407111366</c:v>
                </c:pt>
                <c:pt idx="2">
                  <c:v>6.95260752165277</c:v>
                </c:pt>
                <c:pt idx="3">
                  <c:v>7.459458271655634</c:v>
                </c:pt>
                <c:pt idx="4">
                  <c:v>7.035548622394072</c:v>
                </c:pt>
                <c:pt idx="5">
                  <c:v>8.102941521063632</c:v>
                </c:pt>
                <c:pt idx="6">
                  <c:v>7.44717742258</c:v>
                </c:pt>
                <c:pt idx="7">
                  <c:v>9.684182440377498</c:v>
                </c:pt>
                <c:pt idx="8">
                  <c:v>8.62121182563286</c:v>
                </c:pt>
                <c:pt idx="9">
                  <c:v>7.636355530136726</c:v>
                </c:pt>
                <c:pt idx="10">
                  <c:v>5.786438550557967</c:v>
                </c:pt>
                <c:pt idx="11">
                  <c:v>9.694572123028967</c:v>
                </c:pt>
                <c:pt idx="12">
                  <c:v>7.0282292630115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7631672"/>
        <c:axId val="-2127661768"/>
      </c:lineChart>
      <c:catAx>
        <c:axId val="-21276316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800000"/>
          <a:lstStyle/>
          <a:p>
            <a:pPr>
              <a:defRPr/>
            </a:pPr>
            <a:endParaRPr lang="it-IT"/>
          </a:p>
        </c:txPr>
        <c:crossAx val="-2127661768"/>
        <c:crosses val="autoZero"/>
        <c:auto val="1"/>
        <c:lblAlgn val="ctr"/>
        <c:lblOffset val="100"/>
        <c:tickLblSkip val="1"/>
        <c:noMultiLvlLbl val="0"/>
      </c:catAx>
      <c:valAx>
        <c:axId val="-2127661768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-21276316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2!$J$2</c:f>
              <c:strCache>
                <c:ptCount val="1"/>
                <c:pt idx="0">
                  <c:v>TaTZF5</c:v>
                </c:pt>
              </c:strCache>
            </c:strRef>
          </c:tx>
          <c:cat>
            <c:strRef>
              <c:f>Foglio2!$I$3:$I$15</c:f>
              <c:strCache>
                <c:ptCount val="13"/>
                <c:pt idx="0">
                  <c:v>1: germinating seed, coleoptile</c:v>
                </c:pt>
                <c:pt idx="1">
                  <c:v>2: germinating seed, root</c:v>
                </c:pt>
                <c:pt idx="2">
                  <c:v>3: germinating seed, embryo</c:v>
                </c:pt>
                <c:pt idx="3">
                  <c:v>4: seedling, root</c:v>
                </c:pt>
                <c:pt idx="4">
                  <c:v>5: seedling, crown</c:v>
                </c:pt>
                <c:pt idx="5">
                  <c:v>6: seedling, leaf</c:v>
                </c:pt>
                <c:pt idx="6">
                  <c:v>7: immature inflorescence</c:v>
                </c:pt>
                <c:pt idx="7">
                  <c:v>8: floral bracts, before anthesis</c:v>
                </c:pt>
                <c:pt idx="8">
                  <c:v>9: pistil, before anthesis</c:v>
                </c:pt>
                <c:pt idx="9">
                  <c:v>10: anthers, before anthesis</c:v>
                </c:pt>
                <c:pt idx="10">
                  <c:v>11: 3-5 DAP caryopsis</c:v>
                </c:pt>
                <c:pt idx="11">
                  <c:v>12: 22 DAP embryo</c:v>
                </c:pt>
                <c:pt idx="12">
                  <c:v>13: 22 DAP endosperm</c:v>
                </c:pt>
              </c:strCache>
            </c:strRef>
          </c:cat>
          <c:val>
            <c:numRef>
              <c:f>Foglio2!$J$3:$J$15</c:f>
              <c:numCache>
                <c:formatCode>0.00</c:formatCode>
                <c:ptCount val="13"/>
                <c:pt idx="0">
                  <c:v>6.003769919090873</c:v>
                </c:pt>
                <c:pt idx="1">
                  <c:v>7.21077018506241</c:v>
                </c:pt>
                <c:pt idx="2">
                  <c:v>7.719583789924341</c:v>
                </c:pt>
                <c:pt idx="3">
                  <c:v>6.73750381294377</c:v>
                </c:pt>
                <c:pt idx="4">
                  <c:v>6.766241277976698</c:v>
                </c:pt>
                <c:pt idx="5">
                  <c:v>6.171157376566128</c:v>
                </c:pt>
                <c:pt idx="6">
                  <c:v>2.424700032181734</c:v>
                </c:pt>
                <c:pt idx="7">
                  <c:v>9.841777699002165</c:v>
                </c:pt>
                <c:pt idx="8">
                  <c:v>5.217423517435027</c:v>
                </c:pt>
                <c:pt idx="9">
                  <c:v>5.581495318785066</c:v>
                </c:pt>
                <c:pt idx="10">
                  <c:v>6.491401085452188</c:v>
                </c:pt>
                <c:pt idx="11">
                  <c:v>12.98507353416035</c:v>
                </c:pt>
                <c:pt idx="12">
                  <c:v>12.71052139924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7624504"/>
        <c:axId val="-2127651976"/>
      </c:lineChart>
      <c:catAx>
        <c:axId val="-2127624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800000"/>
          <a:lstStyle/>
          <a:p>
            <a:pPr>
              <a:defRPr/>
            </a:pPr>
            <a:endParaRPr lang="it-IT"/>
          </a:p>
        </c:txPr>
        <c:crossAx val="-2127651976"/>
        <c:crosses val="autoZero"/>
        <c:auto val="1"/>
        <c:lblAlgn val="ctr"/>
        <c:lblOffset val="100"/>
        <c:tickLblSkip val="1"/>
        <c:noMultiLvlLbl val="0"/>
      </c:catAx>
      <c:valAx>
        <c:axId val="-2127651976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-21276245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oglio4!$B$2</c:f>
              <c:strCache>
                <c:ptCount val="1"/>
                <c:pt idx="0">
                  <c:v>TaTZF4</c:v>
                </c:pt>
              </c:strCache>
            </c:strRef>
          </c:tx>
          <c:cat>
            <c:strRef>
              <c:f>Foglio4!$A$3:$A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B$3:$B$11</c:f>
              <c:numCache>
                <c:formatCode>General</c:formatCode>
                <c:ptCount val="9"/>
                <c:pt idx="0">
                  <c:v>2.381182080924</c:v>
                </c:pt>
                <c:pt idx="1">
                  <c:v>3.1214929179759</c:v>
                </c:pt>
                <c:pt idx="2">
                  <c:v>2.929172831766133</c:v>
                </c:pt>
                <c:pt idx="3">
                  <c:v>2.265950622507471</c:v>
                </c:pt>
                <c:pt idx="4">
                  <c:v>2.190869918861</c:v>
                </c:pt>
                <c:pt idx="5">
                  <c:v>2.667869864501035</c:v>
                </c:pt>
                <c:pt idx="6">
                  <c:v>2.643839158019867</c:v>
                </c:pt>
                <c:pt idx="7">
                  <c:v>3.08272469574234</c:v>
                </c:pt>
                <c:pt idx="8">
                  <c:v>2.68639708572090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oglio4!$C$2</c:f>
              <c:strCache>
                <c:ptCount val="1"/>
                <c:pt idx="0">
                  <c:v>TaTZF6</c:v>
                </c:pt>
              </c:strCache>
            </c:strRef>
          </c:tx>
          <c:cat>
            <c:strRef>
              <c:f>Foglio4!$A$3:$A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C$3:$C$11</c:f>
              <c:numCache>
                <c:formatCode>General</c:formatCode>
                <c:ptCount val="9"/>
                <c:pt idx="0">
                  <c:v>6.325836392587965</c:v>
                </c:pt>
                <c:pt idx="1">
                  <c:v>7.474146566256167</c:v>
                </c:pt>
                <c:pt idx="2">
                  <c:v>6.510949290733342</c:v>
                </c:pt>
                <c:pt idx="3">
                  <c:v>5.891942272056634</c:v>
                </c:pt>
                <c:pt idx="4">
                  <c:v>6.96036430298877</c:v>
                </c:pt>
                <c:pt idx="5">
                  <c:v>7.385998761368967</c:v>
                </c:pt>
                <c:pt idx="6">
                  <c:v>7.09600555880913</c:v>
                </c:pt>
                <c:pt idx="7">
                  <c:v>7.123842898014638</c:v>
                </c:pt>
                <c:pt idx="8">
                  <c:v>7.14875192372576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oglio4!$D$2</c:f>
              <c:strCache>
                <c:ptCount val="1"/>
                <c:pt idx="0">
                  <c:v>TuTZF1</c:v>
                </c:pt>
              </c:strCache>
            </c:strRef>
          </c:tx>
          <c:cat>
            <c:strRef>
              <c:f>Foglio4!$A$3:$A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D$3:$D$11</c:f>
              <c:numCache>
                <c:formatCode>General</c:formatCode>
                <c:ptCount val="9"/>
                <c:pt idx="0">
                  <c:v>10.82221347051067</c:v>
                </c:pt>
                <c:pt idx="1">
                  <c:v>10.3615652390837</c:v>
                </c:pt>
                <c:pt idx="2">
                  <c:v>9.922703161011965</c:v>
                </c:pt>
                <c:pt idx="3">
                  <c:v>9.771604904689866</c:v>
                </c:pt>
                <c:pt idx="4">
                  <c:v>9.68065923828427</c:v>
                </c:pt>
                <c:pt idx="5">
                  <c:v>9.59150963722799</c:v>
                </c:pt>
                <c:pt idx="6">
                  <c:v>9.81815497867067</c:v>
                </c:pt>
                <c:pt idx="7">
                  <c:v>9.619998104973867</c:v>
                </c:pt>
                <c:pt idx="8">
                  <c:v>9.85933202302185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oglio4!$E$2</c:f>
              <c:strCache>
                <c:ptCount val="1"/>
                <c:pt idx="0">
                  <c:v>TaTFZ3</c:v>
                </c:pt>
              </c:strCache>
            </c:strRef>
          </c:tx>
          <c:cat>
            <c:strRef>
              <c:f>Foglio4!$A$3:$A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E$3:$E$11</c:f>
              <c:numCache>
                <c:formatCode>General</c:formatCode>
                <c:ptCount val="9"/>
                <c:pt idx="0">
                  <c:v>13.55116629975402</c:v>
                </c:pt>
                <c:pt idx="1">
                  <c:v>13.30298883908704</c:v>
                </c:pt>
                <c:pt idx="2">
                  <c:v>13.88316652062502</c:v>
                </c:pt>
                <c:pt idx="3">
                  <c:v>12.52837251313433</c:v>
                </c:pt>
                <c:pt idx="4">
                  <c:v>12.90245732166636</c:v>
                </c:pt>
                <c:pt idx="5">
                  <c:v>12.80471100032</c:v>
                </c:pt>
                <c:pt idx="6">
                  <c:v>12.67435072790033</c:v>
                </c:pt>
                <c:pt idx="7">
                  <c:v>12.74893910982767</c:v>
                </c:pt>
                <c:pt idx="8">
                  <c:v>12.9255950759697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Foglio4!$F$2</c:f>
              <c:strCache>
                <c:ptCount val="1"/>
                <c:pt idx="0">
                  <c:v>TaTFZ27/TaTFZ7</c:v>
                </c:pt>
              </c:strCache>
            </c:strRef>
          </c:tx>
          <c:cat>
            <c:strRef>
              <c:f>Foglio4!$A$3:$A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F$3:$F$11</c:f>
              <c:numCache>
                <c:formatCode>General</c:formatCode>
                <c:ptCount val="9"/>
                <c:pt idx="0">
                  <c:v>13.72828610829433</c:v>
                </c:pt>
                <c:pt idx="1">
                  <c:v>12.42208223484337</c:v>
                </c:pt>
                <c:pt idx="2">
                  <c:v>12.45183937107802</c:v>
                </c:pt>
                <c:pt idx="3">
                  <c:v>12.50024998841334</c:v>
                </c:pt>
                <c:pt idx="4">
                  <c:v>12.15572568389133</c:v>
                </c:pt>
                <c:pt idx="5">
                  <c:v>11.86546966884704</c:v>
                </c:pt>
                <c:pt idx="6">
                  <c:v>11.49959438112202</c:v>
                </c:pt>
                <c:pt idx="7">
                  <c:v>11.18556173688034</c:v>
                </c:pt>
                <c:pt idx="8">
                  <c:v>11.063440651882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6853016"/>
        <c:axId val="2086855784"/>
      </c:lineChart>
      <c:catAx>
        <c:axId val="2086853016"/>
        <c:scaling>
          <c:orientation val="minMax"/>
        </c:scaling>
        <c:delete val="0"/>
        <c:axPos val="b"/>
        <c:majorTickMark val="out"/>
        <c:minorTickMark val="none"/>
        <c:tickLblPos val="nextTo"/>
        <c:crossAx val="2086855784"/>
        <c:crosses val="autoZero"/>
        <c:auto val="1"/>
        <c:lblAlgn val="ctr"/>
        <c:lblOffset val="100"/>
        <c:noMultiLvlLbl val="0"/>
      </c:catAx>
      <c:valAx>
        <c:axId val="20868557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8685301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4!$H$2</c:f>
              <c:strCache>
                <c:ptCount val="1"/>
                <c:pt idx="0">
                  <c:v>TaTFZ1/TdTZF1</c:v>
                </c:pt>
              </c:strCache>
            </c:strRef>
          </c:tx>
          <c:cat>
            <c:strRef>
              <c:f>Foglio4!$G$3:$G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H$3:$H$11</c:f>
              <c:numCache>
                <c:formatCode>General</c:formatCode>
                <c:ptCount val="9"/>
                <c:pt idx="0">
                  <c:v>9.421313677420825</c:v>
                </c:pt>
                <c:pt idx="1">
                  <c:v>8.45653273778777</c:v>
                </c:pt>
                <c:pt idx="2">
                  <c:v>6.897395532304234</c:v>
                </c:pt>
                <c:pt idx="3">
                  <c:v>5.604972975846477</c:v>
                </c:pt>
                <c:pt idx="4">
                  <c:v>6.218986950693087</c:v>
                </c:pt>
                <c:pt idx="5">
                  <c:v>5.8904462140891</c:v>
                </c:pt>
                <c:pt idx="6">
                  <c:v>7.533174691171968</c:v>
                </c:pt>
                <c:pt idx="7">
                  <c:v>6.946696405949412</c:v>
                </c:pt>
                <c:pt idx="8">
                  <c:v>4.2826153502040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1262104"/>
        <c:axId val="2081265048"/>
      </c:lineChart>
      <c:catAx>
        <c:axId val="2081262104"/>
        <c:scaling>
          <c:orientation val="minMax"/>
        </c:scaling>
        <c:delete val="0"/>
        <c:axPos val="b"/>
        <c:majorTickMark val="out"/>
        <c:minorTickMark val="none"/>
        <c:tickLblPos val="nextTo"/>
        <c:crossAx val="2081265048"/>
        <c:crosses val="autoZero"/>
        <c:auto val="1"/>
        <c:lblAlgn val="ctr"/>
        <c:lblOffset val="100"/>
        <c:noMultiLvlLbl val="0"/>
      </c:catAx>
      <c:valAx>
        <c:axId val="20812650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812621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4!$J$2</c:f>
              <c:strCache>
                <c:ptCount val="1"/>
                <c:pt idx="0">
                  <c:v>TaTZF5</c:v>
                </c:pt>
              </c:strCache>
            </c:strRef>
          </c:tx>
          <c:cat>
            <c:strRef>
              <c:f>Foglio4!$I$3:$I$11</c:f>
              <c:strCache>
                <c:ptCount val="9"/>
                <c:pt idx="0">
                  <c:v>1: Creso|Control</c:v>
                </c:pt>
                <c:pt idx="1">
                  <c:v>2: Creso|Mild stress</c:v>
                </c:pt>
                <c:pt idx="2">
                  <c:v>3: Creso|Severe stress</c:v>
                </c:pt>
                <c:pt idx="3">
                  <c:v>4: CS|Control</c:v>
                </c:pt>
                <c:pt idx="4">
                  <c:v>5: CS|Mild stress</c:v>
                </c:pt>
                <c:pt idx="5">
                  <c:v>6: CS|Severe stress</c:v>
                </c:pt>
                <c:pt idx="6">
                  <c:v>7: CS-5AL|Control</c:v>
                </c:pt>
                <c:pt idx="7">
                  <c:v>8: CS-5AL|Mild stress</c:v>
                </c:pt>
                <c:pt idx="8">
                  <c:v>9: CS-5AL|Severe stress</c:v>
                </c:pt>
              </c:strCache>
            </c:strRef>
          </c:cat>
          <c:val>
            <c:numRef>
              <c:f>Foglio4!$J$3:$J$11</c:f>
              <c:numCache>
                <c:formatCode>General</c:formatCode>
                <c:ptCount val="9"/>
                <c:pt idx="0">
                  <c:v>10.57691583975868</c:v>
                </c:pt>
                <c:pt idx="1">
                  <c:v>10.24734393846181</c:v>
                </c:pt>
                <c:pt idx="2">
                  <c:v>8.849188612049354</c:v>
                </c:pt>
                <c:pt idx="3">
                  <c:v>9.760457126320902</c:v>
                </c:pt>
                <c:pt idx="4">
                  <c:v>9.341032456321771</c:v>
                </c:pt>
                <c:pt idx="5">
                  <c:v>8.593773255998033</c:v>
                </c:pt>
                <c:pt idx="6">
                  <c:v>9.324869097082567</c:v>
                </c:pt>
                <c:pt idx="7">
                  <c:v>9.144383676876725</c:v>
                </c:pt>
                <c:pt idx="8">
                  <c:v>8.836640466299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1285368"/>
        <c:axId val="2081288312"/>
      </c:lineChart>
      <c:catAx>
        <c:axId val="2081285368"/>
        <c:scaling>
          <c:orientation val="minMax"/>
        </c:scaling>
        <c:delete val="0"/>
        <c:axPos val="b"/>
        <c:majorTickMark val="out"/>
        <c:minorTickMark val="none"/>
        <c:tickLblPos val="nextTo"/>
        <c:crossAx val="2081288312"/>
        <c:crosses val="autoZero"/>
        <c:auto val="1"/>
        <c:lblAlgn val="ctr"/>
        <c:lblOffset val="100"/>
        <c:noMultiLvlLbl val="0"/>
      </c:catAx>
      <c:valAx>
        <c:axId val="20812883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8128536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oglio4!$B$14</c:f>
              <c:strCache>
                <c:ptCount val="1"/>
                <c:pt idx="0">
                  <c:v>TaTZF4</c:v>
                </c:pt>
              </c:strCache>
            </c:strRef>
          </c:tx>
          <c:cat>
            <c:strRef>
              <c:f>Foglio4!$A$15:$A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B$15:$B$18</c:f>
              <c:numCache>
                <c:formatCode>General</c:formatCode>
                <c:ptCount val="4"/>
                <c:pt idx="0">
                  <c:v>1.990152036374303</c:v>
                </c:pt>
                <c:pt idx="1">
                  <c:v>1.7578196632216</c:v>
                </c:pt>
                <c:pt idx="2">
                  <c:v>2.169639238508301</c:v>
                </c:pt>
                <c:pt idx="3">
                  <c:v>2.3904874259423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oglio4!$C$14</c:f>
              <c:strCache>
                <c:ptCount val="1"/>
                <c:pt idx="0">
                  <c:v>TaTZF6</c:v>
                </c:pt>
              </c:strCache>
            </c:strRef>
          </c:tx>
          <c:cat>
            <c:strRef>
              <c:f>Foglio4!$A$15:$A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C$15:$C$18</c:f>
              <c:numCache>
                <c:formatCode>General</c:formatCode>
                <c:ptCount val="4"/>
                <c:pt idx="0">
                  <c:v>8.107386391715501</c:v>
                </c:pt>
                <c:pt idx="1">
                  <c:v>7.3020544254407</c:v>
                </c:pt>
                <c:pt idx="2">
                  <c:v>7.831222494846768</c:v>
                </c:pt>
                <c:pt idx="3">
                  <c:v>7.171857962524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oglio4!$D$14</c:f>
              <c:strCache>
                <c:ptCount val="1"/>
                <c:pt idx="0">
                  <c:v>TuTZF1</c:v>
                </c:pt>
              </c:strCache>
            </c:strRef>
          </c:tx>
          <c:cat>
            <c:strRef>
              <c:f>Foglio4!$A$15:$A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D$15:$D$18</c:f>
              <c:numCache>
                <c:formatCode>General</c:formatCode>
                <c:ptCount val="4"/>
                <c:pt idx="0">
                  <c:v>10.02938499636406</c:v>
                </c:pt>
                <c:pt idx="1">
                  <c:v>9.265075710730587</c:v>
                </c:pt>
                <c:pt idx="2">
                  <c:v>10.10744992729565</c:v>
                </c:pt>
                <c:pt idx="3">
                  <c:v>9.52401871580284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oglio4!$E$14</c:f>
              <c:strCache>
                <c:ptCount val="1"/>
                <c:pt idx="0">
                  <c:v>TaTFZ3</c:v>
                </c:pt>
              </c:strCache>
            </c:strRef>
          </c:tx>
          <c:cat>
            <c:strRef>
              <c:f>Foglio4!$A$15:$A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E$15:$E$18</c:f>
              <c:numCache>
                <c:formatCode>General</c:formatCode>
                <c:ptCount val="4"/>
                <c:pt idx="0">
                  <c:v>12.08150224770651</c:v>
                </c:pt>
                <c:pt idx="1">
                  <c:v>12.81266282883902</c:v>
                </c:pt>
                <c:pt idx="2">
                  <c:v>12.05909452736252</c:v>
                </c:pt>
                <c:pt idx="3">
                  <c:v>12.55633884566201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Foglio4!$F$14</c:f>
              <c:strCache>
                <c:ptCount val="1"/>
                <c:pt idx="0">
                  <c:v>TaTFZ27/TaTFZ7</c:v>
                </c:pt>
              </c:strCache>
            </c:strRef>
          </c:tx>
          <c:cat>
            <c:strRef>
              <c:f>Foglio4!$A$15:$A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F$15:$F$18</c:f>
              <c:numCache>
                <c:formatCode>General</c:formatCode>
                <c:ptCount val="4"/>
                <c:pt idx="0">
                  <c:v>12.32053250742952</c:v>
                </c:pt>
                <c:pt idx="1">
                  <c:v>11.981309352827</c:v>
                </c:pt>
                <c:pt idx="2">
                  <c:v>12.3533172746765</c:v>
                </c:pt>
                <c:pt idx="3">
                  <c:v>10.67965572956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8340840"/>
        <c:axId val="2119010680"/>
      </c:lineChart>
      <c:catAx>
        <c:axId val="2118340840"/>
        <c:scaling>
          <c:orientation val="minMax"/>
        </c:scaling>
        <c:delete val="0"/>
        <c:axPos val="b"/>
        <c:majorTickMark val="out"/>
        <c:minorTickMark val="none"/>
        <c:tickLblPos val="nextTo"/>
        <c:crossAx val="2119010680"/>
        <c:crosses val="autoZero"/>
        <c:auto val="1"/>
        <c:lblAlgn val="ctr"/>
        <c:lblOffset val="100"/>
        <c:noMultiLvlLbl val="0"/>
      </c:catAx>
      <c:valAx>
        <c:axId val="21190106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1834084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4!$H$14</c:f>
              <c:strCache>
                <c:ptCount val="1"/>
                <c:pt idx="0">
                  <c:v>TaTFZ1/TdTZF1</c:v>
                </c:pt>
              </c:strCache>
            </c:strRef>
          </c:tx>
          <c:cat>
            <c:strRef>
              <c:f>Foglio4!$G$15:$G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H$15:$H$18</c:f>
              <c:numCache>
                <c:formatCode>General</c:formatCode>
                <c:ptCount val="4"/>
                <c:pt idx="0">
                  <c:v>8.86588055344238</c:v>
                </c:pt>
                <c:pt idx="1">
                  <c:v>11.15654949767602</c:v>
                </c:pt>
                <c:pt idx="2">
                  <c:v>8.947337774012132</c:v>
                </c:pt>
                <c:pt idx="3">
                  <c:v>11.28050799007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6648344"/>
        <c:axId val="-2126657128"/>
      </c:lineChart>
      <c:catAx>
        <c:axId val="-212664834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6657128"/>
        <c:crosses val="autoZero"/>
        <c:auto val="1"/>
        <c:lblAlgn val="ctr"/>
        <c:lblOffset val="100"/>
        <c:noMultiLvlLbl val="0"/>
      </c:catAx>
      <c:valAx>
        <c:axId val="-21266571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66483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oglio4!$J$14</c:f>
              <c:strCache>
                <c:ptCount val="1"/>
                <c:pt idx="0">
                  <c:v>TaTZF5</c:v>
                </c:pt>
              </c:strCache>
            </c:strRef>
          </c:tx>
          <c:cat>
            <c:strRef>
              <c:f>Foglio4!$I$15:$I$18</c:f>
              <c:strCache>
                <c:ptCount val="4"/>
                <c:pt idx="0">
                  <c:v>1: SD16029 (FR)|25 C</c:v>
                </c:pt>
                <c:pt idx="1">
                  <c:v>2: SD16029 (FR)|4 C</c:v>
                </c:pt>
                <c:pt idx="2">
                  <c:v>3: SD16169 (FS)|25 C</c:v>
                </c:pt>
                <c:pt idx="3">
                  <c:v>4:SD16169 (FS)|4 C</c:v>
                </c:pt>
              </c:strCache>
            </c:strRef>
          </c:cat>
          <c:val>
            <c:numRef>
              <c:f>Foglio4!$J$15:$J$18</c:f>
              <c:numCache>
                <c:formatCode>General</c:formatCode>
                <c:ptCount val="4"/>
                <c:pt idx="0">
                  <c:v>5.62836971063685</c:v>
                </c:pt>
                <c:pt idx="1">
                  <c:v>6.301614650367437</c:v>
                </c:pt>
                <c:pt idx="2">
                  <c:v>5.31020158451555</c:v>
                </c:pt>
                <c:pt idx="3">
                  <c:v>6.9920242224081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6685080"/>
        <c:axId val="-2126682136"/>
      </c:lineChart>
      <c:catAx>
        <c:axId val="-212668508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6682136"/>
        <c:crosses val="autoZero"/>
        <c:auto val="1"/>
        <c:lblAlgn val="ctr"/>
        <c:lblOffset val="100"/>
        <c:noMultiLvlLbl val="0"/>
      </c:catAx>
      <c:valAx>
        <c:axId val="-21266821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668508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125C3-3FFF-4853-B6F9-23C1793AB90B}" type="datetimeFigureOut">
              <a:rPr lang="it-IT" smtClean="0"/>
              <a:pPr/>
              <a:t>26/05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00644C-225E-46BC-A219-A4D9DEDE5B29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eg"/><Relationship Id="rId3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Relationship Id="rId3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4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4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t="19479" r="12686" b="4829"/>
          <a:stretch>
            <a:fillRect/>
          </a:stretch>
        </p:blipFill>
        <p:spPr bwMode="auto">
          <a:xfrm>
            <a:off x="171431" y="23779"/>
            <a:ext cx="6686569" cy="44291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 t="15149" r="11330" b="2897"/>
          <a:stretch>
            <a:fillRect/>
          </a:stretch>
        </p:blipFill>
        <p:spPr bwMode="auto">
          <a:xfrm>
            <a:off x="285728" y="4577935"/>
            <a:ext cx="6572272" cy="45184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CasellaDiTesto 6"/>
          <p:cNvSpPr txBox="1"/>
          <p:nvPr/>
        </p:nvSpPr>
        <p:spPr>
          <a:xfrm rot="16200000">
            <a:off x="-401472" y="1561599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-392146" y="6077765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0" y="9598223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Figure S2</a:t>
            </a:r>
            <a:r>
              <a:rPr lang="it-IT" sz="1400" dirty="0" smtClean="0"/>
              <a:t>-</a:t>
            </a:r>
            <a:r>
              <a:rPr lang="it-IT" sz="1400" dirty="0"/>
              <a:t>A</a:t>
            </a:r>
            <a:r>
              <a:rPr lang="it-IT" sz="1400" dirty="0" smtClean="0"/>
              <a:t>.</a:t>
            </a:r>
            <a:endParaRPr lang="it-IT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 t="14524" r="8914" b="2243"/>
          <a:stretch>
            <a:fillRect/>
          </a:stretch>
        </p:blipFill>
        <p:spPr bwMode="auto">
          <a:xfrm>
            <a:off x="0" y="3167050"/>
            <a:ext cx="6854274" cy="34290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CasellaDiTesto 4"/>
          <p:cNvSpPr txBox="1"/>
          <p:nvPr/>
        </p:nvSpPr>
        <p:spPr>
          <a:xfrm>
            <a:off x="0" y="9598223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/>
              <a:t>Figure S2-B.</a:t>
            </a:r>
            <a:endParaRPr lang="it-IT" sz="1200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 t="13785" r="9053" b="3505"/>
          <a:stretch>
            <a:fillRect/>
          </a:stretch>
        </p:blipFill>
        <p:spPr bwMode="auto">
          <a:xfrm>
            <a:off x="0" y="23779"/>
            <a:ext cx="6888396" cy="30241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CasellaDiTesto 7"/>
          <p:cNvSpPr txBox="1"/>
          <p:nvPr/>
        </p:nvSpPr>
        <p:spPr>
          <a:xfrm rot="16200000">
            <a:off x="-401472" y="1013873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-466273" y="4424066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286125" y="47557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/>
              <a:t>Shoot</a:t>
            </a:r>
            <a:endParaRPr lang="it-IT" sz="14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3429001" y="323849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/>
              <a:t>Shoot</a:t>
            </a:r>
            <a:endParaRPr lang="it-IT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9598223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igure S2-</a:t>
            </a:r>
            <a:r>
              <a:rPr lang="it-IT" sz="1200" dirty="0" smtClean="0"/>
              <a:t>B </a:t>
            </a:r>
            <a:r>
              <a:rPr lang="it-IT" sz="1200" dirty="0" err="1" smtClean="0"/>
              <a:t>continued</a:t>
            </a:r>
            <a:r>
              <a:rPr lang="it-IT" sz="1200" dirty="0" smtClean="0"/>
              <a:t>.</a:t>
            </a:r>
            <a:endParaRPr lang="it-IT" sz="1200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 t="6931" r="8221" b="3484"/>
          <a:stretch>
            <a:fillRect/>
          </a:stretch>
        </p:blipFill>
        <p:spPr bwMode="auto">
          <a:xfrm>
            <a:off x="0" y="23779"/>
            <a:ext cx="6858000" cy="2954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 t="6611" r="9438" b="3512"/>
          <a:stretch>
            <a:fillRect/>
          </a:stretch>
        </p:blipFill>
        <p:spPr bwMode="auto">
          <a:xfrm>
            <a:off x="1" y="3095613"/>
            <a:ext cx="6850221" cy="3357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CasellaDiTesto 8"/>
          <p:cNvSpPr txBox="1"/>
          <p:nvPr/>
        </p:nvSpPr>
        <p:spPr>
          <a:xfrm rot="16200000">
            <a:off x="-466249" y="1042702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214687" y="61879"/>
            <a:ext cx="528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/>
              <a:t>Root</a:t>
            </a:r>
            <a:endParaRPr lang="it-IT" sz="1400" dirty="0"/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-466273" y="4276243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3143249" y="3167052"/>
            <a:ext cx="528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/>
              <a:t>Root</a:t>
            </a:r>
            <a:endParaRPr lang="it-IT" sz="14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-21166" y="8985448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igure S2</a:t>
            </a:r>
            <a:r>
              <a:rPr lang="it-IT" sz="1200" dirty="0" smtClean="0"/>
              <a:t>-C. </a:t>
            </a:r>
          </a:p>
        </p:txBody>
      </p:sp>
      <p:graphicFrame>
        <p:nvGraphicFramePr>
          <p:cNvPr id="8" name="Grafico 7"/>
          <p:cNvGraphicFramePr/>
          <p:nvPr/>
        </p:nvGraphicFramePr>
        <p:xfrm>
          <a:off x="714356" y="238093"/>
          <a:ext cx="5643602" cy="2857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Grafico 8"/>
          <p:cNvGraphicFramePr/>
          <p:nvPr/>
        </p:nvGraphicFramePr>
        <p:xfrm>
          <a:off x="714356" y="3095613"/>
          <a:ext cx="5643602" cy="2571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Grafico 9"/>
          <p:cNvGraphicFramePr/>
          <p:nvPr/>
        </p:nvGraphicFramePr>
        <p:xfrm>
          <a:off x="857232" y="5881694"/>
          <a:ext cx="5143504" cy="2528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CasellaDiTesto 10"/>
          <p:cNvSpPr txBox="1"/>
          <p:nvPr/>
        </p:nvSpPr>
        <p:spPr>
          <a:xfrm rot="16200000">
            <a:off x="899801" y="990094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1042677" y="6490820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899801" y="3704740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/>
          <p:cNvGraphicFramePr/>
          <p:nvPr/>
        </p:nvGraphicFramePr>
        <p:xfrm>
          <a:off x="1214422" y="380968"/>
          <a:ext cx="4572000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/>
          <p:cNvGraphicFramePr/>
          <p:nvPr/>
        </p:nvGraphicFramePr>
        <p:xfrm>
          <a:off x="1214422" y="3095612"/>
          <a:ext cx="4572000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/>
          <p:cNvGraphicFramePr/>
          <p:nvPr/>
        </p:nvGraphicFramePr>
        <p:xfrm>
          <a:off x="1214422" y="5953132"/>
          <a:ext cx="4214842" cy="24288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31957" y="920147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igure S2</a:t>
            </a:r>
            <a:r>
              <a:rPr lang="it-IT" sz="1200" dirty="0" smtClean="0"/>
              <a:t>-D. </a:t>
            </a:r>
            <a:endParaRPr lang="it-IT" sz="1200" dirty="0"/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819611" y="990094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7" name="CasellaDiTesto 6"/>
          <p:cNvSpPr txBox="1"/>
          <p:nvPr/>
        </p:nvSpPr>
        <p:spPr>
          <a:xfrm rot="16200000">
            <a:off x="835487" y="6490820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819611" y="3704740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920147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igure S2</a:t>
            </a:r>
            <a:r>
              <a:rPr lang="it-IT" sz="1200" dirty="0" smtClean="0"/>
              <a:t>-</a:t>
            </a:r>
            <a:r>
              <a:rPr lang="it-IT" sz="1200" dirty="0"/>
              <a:t>E</a:t>
            </a:r>
            <a:r>
              <a:rPr lang="it-IT" sz="1200" dirty="0" smtClean="0"/>
              <a:t>. </a:t>
            </a:r>
            <a:endParaRPr lang="it-IT" sz="1200" dirty="0"/>
          </a:p>
        </p:txBody>
      </p:sp>
      <p:graphicFrame>
        <p:nvGraphicFramePr>
          <p:cNvPr id="4" name="Grafico 3"/>
          <p:cNvGraphicFramePr/>
          <p:nvPr/>
        </p:nvGraphicFramePr>
        <p:xfrm>
          <a:off x="1071546" y="238093"/>
          <a:ext cx="5072098" cy="2857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fico 4"/>
          <p:cNvGraphicFramePr/>
          <p:nvPr/>
        </p:nvGraphicFramePr>
        <p:xfrm>
          <a:off x="1071546" y="3095612"/>
          <a:ext cx="5072098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fico 5"/>
          <p:cNvGraphicFramePr/>
          <p:nvPr/>
        </p:nvGraphicFramePr>
        <p:xfrm>
          <a:off x="1142984" y="5881694"/>
          <a:ext cx="4572000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CasellaDiTesto 6"/>
          <p:cNvSpPr txBox="1"/>
          <p:nvPr/>
        </p:nvSpPr>
        <p:spPr>
          <a:xfrm rot="16200000">
            <a:off x="462421" y="1280793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478297" y="6781519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462421" y="3995438"/>
            <a:ext cx="1209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Expression</a:t>
            </a:r>
            <a:r>
              <a:rPr lang="it-IT" sz="1200" dirty="0" smtClean="0"/>
              <a:t> </a:t>
            </a:r>
            <a:r>
              <a:rPr lang="it-IT" sz="1200" dirty="0" err="1" smtClean="0"/>
              <a:t>Level</a:t>
            </a:r>
            <a:endParaRPr lang="it-IT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>Upload</StageName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B5C10061-E7E6-443B-8664-A0B5D1EF454E}"/>
</file>

<file path=customXml/itemProps2.xml><?xml version="1.0" encoding="utf-8"?>
<ds:datastoreItem xmlns:ds="http://schemas.openxmlformats.org/officeDocument/2006/customXml" ds:itemID="{28D2A2D2-E475-4C7E-AA7B-F489B8D4B660}"/>
</file>

<file path=customXml/itemProps3.xml><?xml version="1.0" encoding="utf-8"?>
<ds:datastoreItem xmlns:ds="http://schemas.openxmlformats.org/officeDocument/2006/customXml" ds:itemID="{DE7550ED-3EB3-40AD-A3BB-AA8375AD748B}"/>
</file>

<file path=docProps/app.xml><?xml version="1.0" encoding="utf-8"?>
<Properties xmlns="http://schemas.openxmlformats.org/officeDocument/2006/extended-properties" xmlns:vt="http://schemas.openxmlformats.org/officeDocument/2006/docPropsVTypes">
  <TotalTime>521</TotalTime>
  <Words>65</Words>
  <Application>Microsoft Macintosh PowerPoint</Application>
  <PresentationFormat>A4 (21x29,7 cm)</PresentationFormat>
  <Paragraphs>25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7" baseType="lpstr">
      <vt:lpstr>Tema di Office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na</dc:creator>
  <cp:lastModifiedBy>Giorgio Morelli</cp:lastModifiedBy>
  <cp:revision>64</cp:revision>
  <dcterms:created xsi:type="dcterms:W3CDTF">2013-10-18T12:30:02Z</dcterms:created>
  <dcterms:modified xsi:type="dcterms:W3CDTF">2015-05-26T17:09:13Z</dcterms:modified>
</cp:coreProperties>
</file>